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099300"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99200" cy="10234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3076560" cy="511200"/>
          </a:xfrm>
          <a:prstGeom prst="rect">
            <a:avLst/>
          </a:prstGeom>
          <a:noFill/>
          <a:ln w="0">
            <a:noFill/>
          </a:ln>
        </p:spPr>
        <p:txBody>
          <a:bodyPr lIns="99000" rIns="99000" tIns="49680" bIns="496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4021200" y="0"/>
            <a:ext cx="3076560" cy="511200"/>
          </a:xfrm>
          <a:prstGeom prst="rect">
            <a:avLst/>
          </a:prstGeom>
          <a:noFill/>
          <a:ln w="0">
            <a:noFill/>
          </a:ln>
        </p:spPr>
        <p:txBody>
          <a:bodyPr lIns="99000" rIns="99000" tIns="49680" bIns="4968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3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300" spc="-1" strike="noStrike">
                <a:solidFill>
                  <a:srgbClr val="000000"/>
                </a:solidFill>
                <a:latin typeface="Calibri"/>
              </a:rPr>
              <a:t>&lt;date/time&gt;</a:t>
            </a:r>
            <a:endParaRPr b="0" lang="en-US" sz="1300" spc="-1" strike="noStrike">
              <a:solidFill>
                <a:srgbClr val="000000"/>
              </a:solidFill>
              <a:latin typeface="Arial"/>
            </a:endParaRPr>
          </a:p>
        </p:txBody>
      </p:sp>
      <p:sp>
        <p:nvSpPr>
          <p:cNvPr id="44" name="PlaceHolder 3"/>
          <p:cNvSpPr>
            <a:spLocks noGrp="1"/>
          </p:cNvSpPr>
          <p:nvPr>
            <p:ph type="sldImg"/>
          </p:nvPr>
        </p:nvSpPr>
        <p:spPr>
          <a:xfrm>
            <a:off x="992160" y="767880"/>
            <a:ext cx="5114880" cy="3837240"/>
          </a:xfrm>
          <a:prstGeom prst="rect">
            <a:avLst/>
          </a:prstGeom>
          <a:noFill/>
          <a:ln w="12600">
            <a:solidFill>
              <a:srgbClr val="000000"/>
            </a:solidFill>
            <a:miter/>
          </a:ln>
        </p:spPr>
        <p:txBody>
          <a:bodyPr lIns="99000" rIns="99000" tIns="49680" bIns="496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09560" y="4861080"/>
            <a:ext cx="5680080" cy="4605120"/>
          </a:xfrm>
          <a:prstGeom prst="rect">
            <a:avLst/>
          </a:prstGeom>
          <a:noFill/>
          <a:ln w="0">
            <a:noFill/>
          </a:ln>
        </p:spPr>
        <p:txBody>
          <a:bodyPr lIns="99000" rIns="99000" tIns="49680" bIns="496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721800"/>
            <a:ext cx="3076560" cy="511200"/>
          </a:xfrm>
          <a:prstGeom prst="rect">
            <a:avLst/>
          </a:prstGeom>
          <a:noFill/>
          <a:ln w="0">
            <a:noFill/>
          </a:ln>
        </p:spPr>
        <p:txBody>
          <a:bodyPr lIns="99000" rIns="99000" tIns="49680" bIns="4968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4021200" y="9721800"/>
            <a:ext cx="3076560" cy="511200"/>
          </a:xfrm>
          <a:prstGeom prst="rect">
            <a:avLst/>
          </a:prstGeom>
          <a:noFill/>
          <a:ln w="0">
            <a:noFill/>
          </a:ln>
        </p:spPr>
        <p:txBody>
          <a:bodyPr lIns="99000" rIns="99000" tIns="49680" bIns="4968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3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87CEF4D-7929-4EDE-B59A-6548AAF82522}" type="slidenum">
              <a:rPr b="0" lang="ja-JP" sz="1300" spc="-1" strike="noStrike">
                <a:solidFill>
                  <a:srgbClr val="000000"/>
                </a:solidFill>
                <a:latin typeface="Calibri"/>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992160" y="768240"/>
            <a:ext cx="5114880" cy="3837240"/>
          </a:xfrm>
          <a:prstGeom prst="rect">
            <a:avLst/>
          </a:prstGeom>
          <a:ln w="0">
            <a:noFill/>
          </a:ln>
        </p:spPr>
      </p:sp>
      <p:sp>
        <p:nvSpPr>
          <p:cNvPr id="53" name="PlaceHolder 2"/>
          <p:cNvSpPr>
            <a:spLocks noGrp="1"/>
          </p:cNvSpPr>
          <p:nvPr>
            <p:ph type="body"/>
          </p:nvPr>
        </p:nvSpPr>
        <p:spPr>
          <a:xfrm>
            <a:off x="709560" y="4861080"/>
            <a:ext cx="5680080" cy="460512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54" name="スライド番号プレースホルダ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9489FCC-6A74-4346-A4FF-ABD0ED2FA2AF}" type="slidenum">
              <a:rPr b="0" lang="ja-JP" sz="1300" spc="-1" strike="noStrike">
                <a:solidFill>
                  <a:srgbClr val="000000"/>
                </a:solidFill>
                <a:latin typeface="Calibri"/>
              </a:rPr>
              <a:t>&lt;number&gt;</a:t>
            </a:fld>
            <a:endParaRPr b="0" lang="en-US" sz="13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 name="PlaceHolder 1"/>
          <p:cNvSpPr>
            <a:spLocks noGrp="1"/>
          </p:cNvSpPr>
          <p:nvPr>
            <p:ph type="sldImg"/>
          </p:nvPr>
        </p:nvSpPr>
        <p:spPr>
          <a:xfrm>
            <a:off x="992160" y="768240"/>
            <a:ext cx="5114880" cy="3837240"/>
          </a:xfrm>
          <a:prstGeom prst="rect">
            <a:avLst/>
          </a:prstGeom>
          <a:ln w="0">
            <a:noFill/>
          </a:ln>
        </p:spPr>
      </p:sp>
      <p:sp>
        <p:nvSpPr>
          <p:cNvPr id="56" name="PlaceHolder 2"/>
          <p:cNvSpPr>
            <a:spLocks noGrp="1"/>
          </p:cNvSpPr>
          <p:nvPr>
            <p:ph type="body"/>
          </p:nvPr>
        </p:nvSpPr>
        <p:spPr>
          <a:xfrm>
            <a:off x="709560" y="4861080"/>
            <a:ext cx="5680080" cy="460512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57" name="スライド番号プレースホルダ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7F8FA58-9DBF-4DFE-A655-B933A999B46D}" type="slidenum">
              <a:rPr b="0" lang="en-US" sz="1300" spc="-1" strike="noStrike">
                <a:solidFill>
                  <a:srgbClr val="000000"/>
                </a:solidFill>
                <a:latin typeface="Calibri"/>
              </a:rPr>
              <a:t>&lt;number&gt;</a:t>
            </a:fld>
            <a:endParaRPr b="0" lang="en-US" sz="13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3C65752-D855-4EF2-B0EA-85BDE57A7E5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EABC0C4-D4AA-474C-9FA1-B0F83263C67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81E3211-C5B3-4D9E-944E-4C190383982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76A63ED-1ED8-466A-ABB0-804182CDB63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4A8A33E-67C7-45D8-BA73-71A7FD94E22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4DC466C-FC97-4AB0-AB77-7B99476806E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3FB53F5-D8BD-44F7-90A0-823578AFE76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B98B7F3-1A88-44A7-A398-A788BFCBDEC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66BA854-467F-4B1C-BECE-9BFB9E72360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6A310B0-914A-4EAC-92D8-9996AE80858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43BA654-BD0A-40D7-AF7D-4561BD6A708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19C983B-E854-4389-8E97-D0F9031A02B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C4A4F26-34A4-45A1-A0D4-BAA704D5A15B}"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テキスト ボックス 1"/>
          <p:cNvSpPr/>
          <p:nvPr/>
        </p:nvSpPr>
        <p:spPr>
          <a:xfrm>
            <a:off x="1395360" y="1268280"/>
            <a:ext cx="5543640" cy="581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Calibri"/>
              </a:rPr>
              <a:t>Additional file 9</a:t>
            </a:r>
            <a:endParaRPr b="0" lang="en-US" sz="3200" spc="-1" strike="noStrike">
              <a:solidFill>
                <a:srgbClr val="000000"/>
              </a:solidFill>
              <a:latin typeface="Arial"/>
            </a:endParaRPr>
          </a:p>
        </p:txBody>
      </p:sp>
      <p:sp>
        <p:nvSpPr>
          <p:cNvPr id="49" name="テキスト ボックス 2"/>
          <p:cNvSpPr/>
          <p:nvPr/>
        </p:nvSpPr>
        <p:spPr>
          <a:xfrm>
            <a:off x="1395360" y="1962000"/>
            <a:ext cx="6696000" cy="3934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All the identified proteins of the non-redundant, high-confidence dataset of glomerulus proteome consisting of 1,817 unique proteins representing 1,478 unique genes were compared with high-confidence, non-redundant dataset of normal human plasma proteome [States DJ et al, </a:t>
            </a:r>
            <a:r>
              <a:rPr b="0" i="1" lang="en-GB" sz="1800" spc="-1" strike="noStrike">
                <a:solidFill>
                  <a:srgbClr val="000000"/>
                </a:solidFill>
                <a:latin typeface="Calibri"/>
              </a:rPr>
              <a:t>Nat. Biotech</a:t>
            </a:r>
            <a:r>
              <a:rPr b="0" lang="en-GB" sz="1800" spc="-1" strike="noStrike">
                <a:solidFill>
                  <a:srgbClr val="000000"/>
                </a:solidFill>
                <a:latin typeface="Calibri"/>
              </a:rPr>
              <a:t>, 2006, </a:t>
            </a:r>
            <a:r>
              <a:rPr b="1" lang="en-GB" sz="1800" spc="-1" strike="noStrike">
                <a:solidFill>
                  <a:srgbClr val="000000"/>
                </a:solidFill>
                <a:latin typeface="Calibri"/>
              </a:rPr>
              <a:t>24</a:t>
            </a:r>
            <a:r>
              <a:rPr b="0" lang="en-GB" sz="1800" spc="-1" strike="noStrike">
                <a:solidFill>
                  <a:srgbClr val="000000"/>
                </a:solidFill>
                <a:latin typeface="Calibri"/>
              </a:rPr>
              <a:t>, 333-338]. Among the 401 overlapped proteins, proteins annotated as “extracellular space” by GO Cellular Component vocabulary were selected as plasma proteins. The top 30 plasma proteins are listed in order according to the number of peptide matches.</a:t>
            </a:r>
            <a:r>
              <a:rPr b="0" lang="ja-JP" sz="1800" spc="-1" strike="noStrike">
                <a:solidFill>
                  <a:srgbClr val="000000"/>
                </a:solidFill>
                <a:latin typeface="Calibri"/>
              </a:rPr>
              <a:t>　</a:t>
            </a:r>
            <a:r>
              <a:rPr b="0" lang="en-US" sz="1800" spc="-1" strike="noStrike">
                <a:solidFill>
                  <a:srgbClr val="000000"/>
                </a:solidFill>
                <a:latin typeface="Calibri"/>
              </a:rPr>
              <a:t>Relative abundance of protein in glomerulus proteome was calculated by normalized spectral abundance factor (NSAF) of each of the identified proteins divided by the lowest NSAF value (IPI100029168, Apolipoprotein (a) with NSAF value of 5.265485E-6). See Additional file 2 and Figure 5 for details.</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TextBox 4"/>
          <p:cNvSpPr/>
          <p:nvPr/>
        </p:nvSpPr>
        <p:spPr>
          <a:xfrm>
            <a:off x="320760" y="196920"/>
            <a:ext cx="785808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Top 30 plasma proteins identified in glomerulus proteome</a:t>
            </a:r>
            <a:endParaRPr b="0" lang="en-US" sz="2000" spc="-1" strike="noStrike">
              <a:solidFill>
                <a:srgbClr val="000000"/>
              </a:solidFill>
              <a:latin typeface="Arial"/>
            </a:endParaRPr>
          </a:p>
        </p:txBody>
      </p:sp>
      <p:graphicFrame>
        <p:nvGraphicFramePr>
          <p:cNvPr id="51" name=""/>
          <p:cNvGraphicFramePr/>
          <p:nvPr/>
        </p:nvGraphicFramePr>
        <p:xfrm>
          <a:off x="304920" y="609480"/>
          <a:ext cx="8588160" cy="6037560"/>
        </p:xfrm>
        <a:graphic>
          <a:graphicData uri="http://schemas.openxmlformats.org/drawingml/2006/table">
            <a:tbl>
              <a:tblPr/>
              <a:tblGrid>
                <a:gridCol w="342720"/>
                <a:gridCol w="777960"/>
                <a:gridCol w="2786040"/>
                <a:gridCol w="1081080"/>
                <a:gridCol w="934920"/>
                <a:gridCol w="1008360"/>
                <a:gridCol w="1657080"/>
              </a:tblGrid>
              <a:tr h="411840">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Unicode MS"/>
                        </a:rPr>
                        <a:t>No.</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Unicode MS"/>
                        </a:rPr>
                        <a:t>IPI Identifier</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Unicode MS"/>
                        </a:rPr>
                        <a:t>Protein Name</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Unicode MS"/>
                        </a:rPr>
                        <a:t>UniProt accession</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Unicode MS"/>
                        </a:rPr>
                        <a:t>Gene symbol</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Unicode MS"/>
                        </a:rPr>
                        <a:t>Total distinct peptides</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Unicode MS"/>
                        </a:rPr>
                        <a:t>Relative  protein abundance in glomerulus proteome</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 </a:t>
                      </a:r>
                      <a:r>
                        <a:rPr b="0" lang="en-US" sz="900" spc="-1" strike="noStrike">
                          <a:solidFill>
                            <a:srgbClr val="000000"/>
                          </a:solidFill>
                          <a:latin typeface="Arial Unicode MS"/>
                        </a:rPr>
                        <a:t>in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16462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Complement C3</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102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C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4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8.2</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246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Serotransferr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78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TF</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42</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39.1</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243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Serum album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76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ALB</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9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58.0</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30545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alpha-1-Antitryps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100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SERPINA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8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13.7</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3225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Complement C4</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102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C4A</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5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5.6</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16942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SNC66 prote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Q96K6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GHA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2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36.6</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32846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Fibronectin 1 isoform 2</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Q86T2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FN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1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18.3</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184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Apolipoprotein A-I</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64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APOA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7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272.5</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3I221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Antithrombin-III</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101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SERPINA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7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71.1</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29882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beta-2-Glycoprotein 1</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74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APOH</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7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52.7</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152302</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Unicode MS"/>
                        </a:rPr>
                        <a:t>Ig alpha-1 chain c regio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185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GHG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7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94.4</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2</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3217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Antithrombin-III</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100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SERPINC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6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39.2</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188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Isoform 1 of Fibrinogen alpha cha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671-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FGA</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6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21.0</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0460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Ig gamma-2 chain c regio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185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GHG2</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62</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21.8</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29897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Vitronect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400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VTN</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6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66.6</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291262</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Isoform 1 of Cluster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1090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CLU</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5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41.8</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31428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1891         </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Isoform Gamma-B of Fibrinogen gamma cha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679-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FGG</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5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00.4</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631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Isoform 1 of Gelsol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639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GSN</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4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87.2</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1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172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C4b-binding protein alpha chai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400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C4BPA</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4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06.7</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242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Alpha-1-acid glycoprotein 1</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76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ORM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4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58.4</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30427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Apolipoprotein A-IV</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672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APOA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4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1.5</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2</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16872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Unicode MS"/>
                        </a:rPr>
                        <a:t>Ig alpha-1 chain c regio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Q8NF1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GHM</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4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26.8</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3222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Angiotensinoge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101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AGT</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4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9.4</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29609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Thrombospondin-1</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799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THBS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4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1.7</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22032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i-FI" sz="1000" spc="-1" strike="noStrike">
                          <a:solidFill>
                            <a:srgbClr val="000000"/>
                          </a:solidFill>
                          <a:latin typeface="Arial Unicode MS"/>
                        </a:rPr>
                        <a:t>Keratin, type II cytoskeletal 1</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426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KRT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3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734.5</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098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Lumican</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5188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LUM</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3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148.0</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7</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239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Complement component C9</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74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C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3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8.1</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24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8</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2426</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Protein AMBP</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76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AMBP</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33</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25.8</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8360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021842</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Apolipoprotein E</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264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APOE</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3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301.3</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r h="174960">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30</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IPI00294004</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Vitamin K-dependent protein S</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07225</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PROS1</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36000" rIns="18000" tIns="0" bIns="0" anchor="ctr">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Unicode MS"/>
                        </a:rPr>
                        <a:t>29</a:t>
                      </a:r>
                      <a:endParaRPr b="0" lang="en-US" sz="900" spc="-1" strike="noStrike">
                        <a:solidFill>
                          <a:srgbClr val="000000"/>
                        </a:solidFill>
                        <a:latin typeface="Arial"/>
                      </a:endParaRPr>
                    </a:p>
                  </a:txBody>
                  <a:tcPr anchor="ctr" marL="36000" marR="1800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Unicode MS"/>
                        </a:rPr>
                        <a:t>6.7</a:t>
                      </a:r>
                      <a:endParaRPr b="0" lang="en-US" sz="10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0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7-10T06:30:37Z</dcterms:created>
  <dc:creator>Yutaka Yoshida</dc:creator>
  <dc:description/>
  <dc:language>en-US</dc:language>
  <cp:lastModifiedBy>Yutaka Yoshida</cp:lastModifiedBy>
  <dcterms:modified xsi:type="dcterms:W3CDTF">2013-03-27T03:01:08Z</dcterms:modified>
  <cp:revision>34</cp:revision>
  <dc:subject/>
  <dc:title>スライド 1</dc:title>
</cp:coreProperties>
</file>